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918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976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9416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701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602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3490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4764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97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856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8245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143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485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05288-A764-4EC8-A1DF-F9536A3DBB3F}" type="datetimeFigureOut">
              <a:rPr lang="fr-FR" smtClean="0"/>
              <a:t>06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CA931-8E05-4597-A600-16410D5894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8261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79512" y="620688"/>
            <a:ext cx="4725987" cy="4621213"/>
            <a:chOff x="2489200" y="1425575"/>
            <a:chExt cx="4725987" cy="4621213"/>
          </a:xfrm>
        </p:grpSpPr>
        <p:sp>
          <p:nvSpPr>
            <p:cNvPr id="5" name="Freeform 6"/>
            <p:cNvSpPr>
              <a:spLocks/>
            </p:cNvSpPr>
            <p:nvPr/>
          </p:nvSpPr>
          <p:spPr bwMode="auto">
            <a:xfrm>
              <a:off x="4076700" y="3117850"/>
              <a:ext cx="3138487" cy="2311400"/>
            </a:xfrm>
            <a:custGeom>
              <a:avLst/>
              <a:gdLst>
                <a:gd name="T0" fmla="*/ 0 w 16472"/>
                <a:gd name="T1" fmla="*/ 1316 h 12136"/>
                <a:gd name="T2" fmla="*/ 1316 w 16472"/>
                <a:gd name="T3" fmla="*/ 0 h 12136"/>
                <a:gd name="T4" fmla="*/ 15156 w 16472"/>
                <a:gd name="T5" fmla="*/ 0 h 12136"/>
                <a:gd name="T6" fmla="*/ 16472 w 16472"/>
                <a:gd name="T7" fmla="*/ 1316 h 12136"/>
                <a:gd name="T8" fmla="*/ 16472 w 16472"/>
                <a:gd name="T9" fmla="*/ 10820 h 12136"/>
                <a:gd name="T10" fmla="*/ 15156 w 16472"/>
                <a:gd name="T11" fmla="*/ 12136 h 12136"/>
                <a:gd name="T12" fmla="*/ 1316 w 16472"/>
                <a:gd name="T13" fmla="*/ 12136 h 12136"/>
                <a:gd name="T14" fmla="*/ 0 w 16472"/>
                <a:gd name="T15" fmla="*/ 10820 h 12136"/>
                <a:gd name="T16" fmla="*/ 0 w 16472"/>
                <a:gd name="T17" fmla="*/ 1316 h 12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6472" h="12136">
                  <a:moveTo>
                    <a:pt x="0" y="1316"/>
                  </a:moveTo>
                  <a:cubicBezTo>
                    <a:pt x="0" y="590"/>
                    <a:pt x="590" y="0"/>
                    <a:pt x="1316" y="0"/>
                  </a:cubicBezTo>
                  <a:lnTo>
                    <a:pt x="15156" y="0"/>
                  </a:lnTo>
                  <a:cubicBezTo>
                    <a:pt x="15883" y="0"/>
                    <a:pt x="16472" y="590"/>
                    <a:pt x="16472" y="1316"/>
                  </a:cubicBezTo>
                  <a:lnTo>
                    <a:pt x="16472" y="10820"/>
                  </a:lnTo>
                  <a:cubicBezTo>
                    <a:pt x="16472" y="11547"/>
                    <a:pt x="15883" y="12136"/>
                    <a:pt x="15156" y="12136"/>
                  </a:cubicBezTo>
                  <a:lnTo>
                    <a:pt x="1316" y="12136"/>
                  </a:lnTo>
                  <a:cubicBezTo>
                    <a:pt x="590" y="12136"/>
                    <a:pt x="0" y="11547"/>
                    <a:pt x="0" y="10820"/>
                  </a:cubicBezTo>
                  <a:lnTo>
                    <a:pt x="0" y="1316"/>
                  </a:lnTo>
                  <a:close/>
                </a:path>
              </a:pathLst>
            </a:custGeom>
            <a:noFill/>
            <a:ln w="28575" cap="flat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>
              <a:off x="4241800" y="3233738"/>
              <a:ext cx="16511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600" dirty="0" smtClean="0">
                  <a:solidFill>
                    <a:srgbClr val="0070C0"/>
                  </a:solidFill>
                  <a:latin typeface="Calibri" pitchFamily="34" charset="0"/>
                </a:rPr>
                <a:t>-&gt;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4471988" y="3233738"/>
              <a:ext cx="20955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7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4622800" y="3233738"/>
              <a:ext cx="8461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xclud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10"/>
            <p:cNvSpPr>
              <a:spLocks noChangeArrowheads="1"/>
            </p:cNvSpPr>
            <p:nvPr/>
          </p:nvSpPr>
          <p:spPr bwMode="auto">
            <a:xfrm>
              <a:off x="5402263" y="3233738"/>
              <a:ext cx="10747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ue to intra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11"/>
            <p:cNvSpPr>
              <a:spLocks noChangeArrowheads="1"/>
            </p:cNvSpPr>
            <p:nvPr/>
          </p:nvSpPr>
          <p:spPr bwMode="auto">
            <a:xfrm>
              <a:off x="6367463" y="3233738"/>
              <a:ext cx="16827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-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>
              <a:off x="4508500" y="3478213"/>
              <a:ext cx="211772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bdominal hypertension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3"/>
            <p:cNvSpPr>
              <a:spLocks noChangeArrowheads="1"/>
            </p:cNvSpPr>
            <p:nvPr/>
          </p:nvSpPr>
          <p:spPr bwMode="auto">
            <a:xfrm>
              <a:off x="4241800" y="3783013"/>
              <a:ext cx="16511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600" dirty="0" smtClean="0">
                  <a:solidFill>
                    <a:srgbClr val="0070C0"/>
                  </a:solidFill>
                  <a:latin typeface="Calibri" pitchFamily="34" charset="0"/>
                </a:rPr>
                <a:t>-&gt;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4471988" y="3783013"/>
              <a:ext cx="20955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>
              <a:off x="4622800" y="3783013"/>
              <a:ext cx="8461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xclud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5402263" y="3783013"/>
              <a:ext cx="4651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ue 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5762625" y="3783013"/>
              <a:ext cx="817562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unstable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4508500" y="4025900"/>
              <a:ext cx="15827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lethysmographic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>
              <a:off x="6022975" y="4025900"/>
              <a:ext cx="57467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ignal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4241800" y="4330700"/>
              <a:ext cx="16511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600" dirty="0" smtClean="0">
                  <a:solidFill>
                    <a:srgbClr val="0070C0"/>
                  </a:solidFill>
                  <a:latin typeface="Calibri" pitchFamily="34" charset="0"/>
                </a:rPr>
                <a:t>-&gt;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21"/>
            <p:cNvSpPr>
              <a:spLocks noChangeArrowheads="1"/>
            </p:cNvSpPr>
            <p:nvPr/>
          </p:nvSpPr>
          <p:spPr bwMode="auto">
            <a:xfrm>
              <a:off x="4471988" y="4330700"/>
              <a:ext cx="20955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2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22"/>
            <p:cNvSpPr>
              <a:spLocks noChangeArrowheads="1"/>
            </p:cNvSpPr>
            <p:nvPr/>
          </p:nvSpPr>
          <p:spPr bwMode="auto">
            <a:xfrm>
              <a:off x="4622800" y="4330700"/>
              <a:ext cx="8461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xclud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23"/>
            <p:cNvSpPr>
              <a:spLocks noChangeArrowheads="1"/>
            </p:cNvSpPr>
            <p:nvPr/>
          </p:nvSpPr>
          <p:spPr bwMode="auto">
            <a:xfrm>
              <a:off x="5402263" y="4330700"/>
              <a:ext cx="68580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ue to 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24"/>
            <p:cNvSpPr>
              <a:spLocks noChangeArrowheads="1"/>
            </p:cNvSpPr>
            <p:nvPr/>
          </p:nvSpPr>
          <p:spPr bwMode="auto">
            <a:xfrm>
              <a:off x="5983288" y="4330700"/>
              <a:ext cx="493712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oth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5"/>
            <p:cNvSpPr>
              <a:spLocks noChangeArrowheads="1"/>
            </p:cNvSpPr>
            <p:nvPr/>
          </p:nvSpPr>
          <p:spPr bwMode="auto">
            <a:xfrm>
              <a:off x="6418263" y="4330700"/>
              <a:ext cx="49530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intra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26"/>
            <p:cNvSpPr>
              <a:spLocks noChangeArrowheads="1"/>
            </p:cNvSpPr>
            <p:nvPr/>
          </p:nvSpPr>
          <p:spPr bwMode="auto">
            <a:xfrm>
              <a:off x="6802438" y="4330700"/>
              <a:ext cx="16827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-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27"/>
            <p:cNvSpPr>
              <a:spLocks noChangeArrowheads="1"/>
            </p:cNvSpPr>
            <p:nvPr/>
          </p:nvSpPr>
          <p:spPr bwMode="auto">
            <a:xfrm>
              <a:off x="4508500" y="4575175"/>
              <a:ext cx="2519362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bdominal hypertension and 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4508500" y="4819650"/>
              <a:ext cx="817562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unstable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9"/>
            <p:cNvSpPr>
              <a:spLocks noChangeArrowheads="1"/>
            </p:cNvSpPr>
            <p:nvPr/>
          </p:nvSpPr>
          <p:spPr bwMode="auto">
            <a:xfrm>
              <a:off x="5262563" y="4819650"/>
              <a:ext cx="15827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lethysmographic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4508500" y="5062538"/>
              <a:ext cx="57467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ignal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Freeform 31"/>
            <p:cNvSpPr>
              <a:spLocks/>
            </p:cNvSpPr>
            <p:nvPr/>
          </p:nvSpPr>
          <p:spPr bwMode="auto">
            <a:xfrm>
              <a:off x="4076700" y="2281238"/>
              <a:ext cx="3138487" cy="647700"/>
            </a:xfrm>
            <a:custGeom>
              <a:avLst/>
              <a:gdLst>
                <a:gd name="T0" fmla="*/ 0 w 16472"/>
                <a:gd name="T1" fmla="*/ 567 h 3400"/>
                <a:gd name="T2" fmla="*/ 567 w 16472"/>
                <a:gd name="T3" fmla="*/ 0 h 3400"/>
                <a:gd name="T4" fmla="*/ 15906 w 16472"/>
                <a:gd name="T5" fmla="*/ 0 h 3400"/>
                <a:gd name="T6" fmla="*/ 16472 w 16472"/>
                <a:gd name="T7" fmla="*/ 567 h 3400"/>
                <a:gd name="T8" fmla="*/ 16472 w 16472"/>
                <a:gd name="T9" fmla="*/ 2834 h 3400"/>
                <a:gd name="T10" fmla="*/ 15906 w 16472"/>
                <a:gd name="T11" fmla="*/ 3400 h 3400"/>
                <a:gd name="T12" fmla="*/ 567 w 16472"/>
                <a:gd name="T13" fmla="*/ 3400 h 3400"/>
                <a:gd name="T14" fmla="*/ 0 w 16472"/>
                <a:gd name="T15" fmla="*/ 2834 h 3400"/>
                <a:gd name="T16" fmla="*/ 0 w 16472"/>
                <a:gd name="T17" fmla="*/ 567 h 34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6472" h="3400">
                  <a:moveTo>
                    <a:pt x="0" y="567"/>
                  </a:moveTo>
                  <a:cubicBezTo>
                    <a:pt x="0" y="254"/>
                    <a:pt x="254" y="0"/>
                    <a:pt x="567" y="0"/>
                  </a:cubicBezTo>
                  <a:lnTo>
                    <a:pt x="15906" y="0"/>
                  </a:lnTo>
                  <a:cubicBezTo>
                    <a:pt x="16219" y="0"/>
                    <a:pt x="16472" y="254"/>
                    <a:pt x="16472" y="567"/>
                  </a:cubicBezTo>
                  <a:lnTo>
                    <a:pt x="16472" y="2834"/>
                  </a:lnTo>
                  <a:cubicBezTo>
                    <a:pt x="16472" y="3147"/>
                    <a:pt x="16219" y="3400"/>
                    <a:pt x="15906" y="3400"/>
                  </a:cubicBezTo>
                  <a:lnTo>
                    <a:pt x="567" y="3400"/>
                  </a:lnTo>
                  <a:cubicBezTo>
                    <a:pt x="254" y="3400"/>
                    <a:pt x="0" y="3147"/>
                    <a:pt x="0" y="2834"/>
                  </a:cubicBezTo>
                  <a:lnTo>
                    <a:pt x="0" y="567"/>
                  </a:lnTo>
                  <a:close/>
                </a:path>
              </a:pathLst>
            </a:custGeom>
            <a:noFill/>
            <a:ln w="28575" cap="flat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4200525" y="2355850"/>
              <a:ext cx="16511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600" dirty="0" smtClean="0">
                  <a:solidFill>
                    <a:srgbClr val="0070C0"/>
                  </a:solidFill>
                  <a:latin typeface="Calibri" pitchFamily="34" charset="0"/>
                </a:rPr>
                <a:t>-&gt;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33"/>
            <p:cNvSpPr>
              <a:spLocks noChangeArrowheads="1"/>
            </p:cNvSpPr>
            <p:nvPr/>
          </p:nvSpPr>
          <p:spPr bwMode="auto">
            <a:xfrm>
              <a:off x="4430713" y="2355850"/>
              <a:ext cx="25400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3 </a:t>
              </a:r>
              <a:endParaRPr kumimoji="0" lang="fr-FR" alt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34"/>
            <p:cNvSpPr>
              <a:spLocks noChangeArrowheads="1"/>
            </p:cNvSpPr>
            <p:nvPr/>
          </p:nvSpPr>
          <p:spPr bwMode="auto">
            <a:xfrm>
              <a:off x="4579938" y="2355850"/>
              <a:ext cx="8461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xclud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35"/>
            <p:cNvSpPr>
              <a:spLocks noChangeArrowheads="1"/>
            </p:cNvSpPr>
            <p:nvPr/>
          </p:nvSpPr>
          <p:spPr bwMode="auto">
            <a:xfrm>
              <a:off x="5360988" y="2355850"/>
              <a:ext cx="1625600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ue to absence of 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6"/>
            <p:cNvSpPr>
              <a:spLocks noChangeArrowheads="1"/>
            </p:cNvSpPr>
            <p:nvPr/>
          </p:nvSpPr>
          <p:spPr bwMode="auto">
            <a:xfrm>
              <a:off x="4467225" y="2600325"/>
              <a:ext cx="1582737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lethysmographic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37"/>
            <p:cNvSpPr>
              <a:spLocks noChangeArrowheads="1"/>
            </p:cNvSpPr>
            <p:nvPr/>
          </p:nvSpPr>
          <p:spPr bwMode="auto">
            <a:xfrm>
              <a:off x="5980113" y="2600325"/>
              <a:ext cx="574675" cy="303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ignal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Freeform 38"/>
            <p:cNvSpPr>
              <a:spLocks/>
            </p:cNvSpPr>
            <p:nvPr/>
          </p:nvSpPr>
          <p:spPr bwMode="auto">
            <a:xfrm>
              <a:off x="2489200" y="1425575"/>
              <a:ext cx="1225550" cy="690563"/>
            </a:xfrm>
            <a:custGeom>
              <a:avLst/>
              <a:gdLst>
                <a:gd name="T0" fmla="*/ 0 w 12864"/>
                <a:gd name="T1" fmla="*/ 1208 h 7248"/>
                <a:gd name="T2" fmla="*/ 1208 w 12864"/>
                <a:gd name="T3" fmla="*/ 0 h 7248"/>
                <a:gd name="T4" fmla="*/ 11656 w 12864"/>
                <a:gd name="T5" fmla="*/ 0 h 7248"/>
                <a:gd name="T6" fmla="*/ 12864 w 12864"/>
                <a:gd name="T7" fmla="*/ 1208 h 7248"/>
                <a:gd name="T8" fmla="*/ 12864 w 12864"/>
                <a:gd name="T9" fmla="*/ 6040 h 7248"/>
                <a:gd name="T10" fmla="*/ 11656 w 12864"/>
                <a:gd name="T11" fmla="*/ 7248 h 7248"/>
                <a:gd name="T12" fmla="*/ 1208 w 12864"/>
                <a:gd name="T13" fmla="*/ 7248 h 7248"/>
                <a:gd name="T14" fmla="*/ 0 w 12864"/>
                <a:gd name="T15" fmla="*/ 6040 h 7248"/>
                <a:gd name="T16" fmla="*/ 0 w 12864"/>
                <a:gd name="T17" fmla="*/ 1208 h 7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2864" h="7248">
                  <a:moveTo>
                    <a:pt x="0" y="1208"/>
                  </a:moveTo>
                  <a:cubicBezTo>
                    <a:pt x="0" y="541"/>
                    <a:pt x="541" y="0"/>
                    <a:pt x="1208" y="0"/>
                  </a:cubicBezTo>
                  <a:lnTo>
                    <a:pt x="11656" y="0"/>
                  </a:lnTo>
                  <a:cubicBezTo>
                    <a:pt x="12324" y="0"/>
                    <a:pt x="12864" y="541"/>
                    <a:pt x="12864" y="1208"/>
                  </a:cubicBezTo>
                  <a:lnTo>
                    <a:pt x="12864" y="6040"/>
                  </a:lnTo>
                  <a:cubicBezTo>
                    <a:pt x="12864" y="6708"/>
                    <a:pt x="12324" y="7248"/>
                    <a:pt x="11656" y="7248"/>
                  </a:cubicBezTo>
                  <a:lnTo>
                    <a:pt x="1208" y="7248"/>
                  </a:lnTo>
                  <a:cubicBezTo>
                    <a:pt x="541" y="7248"/>
                    <a:pt x="0" y="6708"/>
                    <a:pt x="0" y="6040"/>
                  </a:cubicBezTo>
                  <a:lnTo>
                    <a:pt x="0" y="1208"/>
                  </a:lnTo>
                  <a:close/>
                </a:path>
              </a:pathLst>
            </a:custGeom>
            <a:noFill/>
            <a:ln w="28575" cap="flat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" name="Rectangle 39"/>
            <p:cNvSpPr>
              <a:spLocks noChangeArrowheads="1"/>
            </p:cNvSpPr>
            <p:nvPr/>
          </p:nvSpPr>
          <p:spPr bwMode="auto">
            <a:xfrm>
              <a:off x="2841625" y="1462088"/>
              <a:ext cx="708025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n=85 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40"/>
            <p:cNvSpPr>
              <a:spLocks noChangeArrowheads="1"/>
            </p:cNvSpPr>
            <p:nvPr/>
          </p:nvSpPr>
          <p:spPr bwMode="auto">
            <a:xfrm>
              <a:off x="2632075" y="1766888"/>
              <a:ext cx="1077912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creen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Freeform 41"/>
            <p:cNvSpPr>
              <a:spLocks/>
            </p:cNvSpPr>
            <p:nvPr/>
          </p:nvSpPr>
          <p:spPr bwMode="auto">
            <a:xfrm>
              <a:off x="2489200" y="3121025"/>
              <a:ext cx="1225550" cy="712788"/>
            </a:xfrm>
            <a:custGeom>
              <a:avLst/>
              <a:gdLst>
                <a:gd name="T0" fmla="*/ 0 w 6432"/>
                <a:gd name="T1" fmla="*/ 624 h 3744"/>
                <a:gd name="T2" fmla="*/ 624 w 6432"/>
                <a:gd name="T3" fmla="*/ 0 h 3744"/>
                <a:gd name="T4" fmla="*/ 5808 w 6432"/>
                <a:gd name="T5" fmla="*/ 0 h 3744"/>
                <a:gd name="T6" fmla="*/ 6432 w 6432"/>
                <a:gd name="T7" fmla="*/ 624 h 3744"/>
                <a:gd name="T8" fmla="*/ 6432 w 6432"/>
                <a:gd name="T9" fmla="*/ 3120 h 3744"/>
                <a:gd name="T10" fmla="*/ 5808 w 6432"/>
                <a:gd name="T11" fmla="*/ 3744 h 3744"/>
                <a:gd name="T12" fmla="*/ 624 w 6432"/>
                <a:gd name="T13" fmla="*/ 3744 h 3744"/>
                <a:gd name="T14" fmla="*/ 0 w 6432"/>
                <a:gd name="T15" fmla="*/ 3120 h 3744"/>
                <a:gd name="T16" fmla="*/ 0 w 6432"/>
                <a:gd name="T17" fmla="*/ 624 h 37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432" h="3744">
                  <a:moveTo>
                    <a:pt x="0" y="624"/>
                  </a:moveTo>
                  <a:cubicBezTo>
                    <a:pt x="0" y="280"/>
                    <a:pt x="280" y="0"/>
                    <a:pt x="624" y="0"/>
                  </a:cubicBezTo>
                  <a:lnTo>
                    <a:pt x="5808" y="0"/>
                  </a:lnTo>
                  <a:cubicBezTo>
                    <a:pt x="6153" y="0"/>
                    <a:pt x="6432" y="280"/>
                    <a:pt x="6432" y="624"/>
                  </a:cubicBezTo>
                  <a:lnTo>
                    <a:pt x="6432" y="3120"/>
                  </a:lnTo>
                  <a:cubicBezTo>
                    <a:pt x="6432" y="3465"/>
                    <a:pt x="6153" y="3744"/>
                    <a:pt x="5808" y="3744"/>
                  </a:cubicBezTo>
                  <a:lnTo>
                    <a:pt x="624" y="3744"/>
                  </a:lnTo>
                  <a:cubicBezTo>
                    <a:pt x="280" y="3744"/>
                    <a:pt x="0" y="3465"/>
                    <a:pt x="0" y="3120"/>
                  </a:cubicBezTo>
                  <a:lnTo>
                    <a:pt x="0" y="624"/>
                  </a:lnTo>
                  <a:close/>
                </a:path>
              </a:pathLst>
            </a:custGeom>
            <a:noFill/>
            <a:ln w="28575" cap="flat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" name="Rectangle 42"/>
            <p:cNvSpPr>
              <a:spLocks noChangeArrowheads="1"/>
            </p:cNvSpPr>
            <p:nvPr/>
          </p:nvSpPr>
          <p:spPr bwMode="auto">
            <a:xfrm>
              <a:off x="2841625" y="3168650"/>
              <a:ext cx="650875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n=82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3"/>
            <p:cNvSpPr>
              <a:spLocks noChangeArrowheads="1"/>
            </p:cNvSpPr>
            <p:nvPr/>
          </p:nvSpPr>
          <p:spPr bwMode="auto">
            <a:xfrm>
              <a:off x="2649538" y="3473450"/>
              <a:ext cx="1044575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nalyz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Freeform 44"/>
            <p:cNvSpPr>
              <a:spLocks/>
            </p:cNvSpPr>
            <p:nvPr/>
          </p:nvSpPr>
          <p:spPr bwMode="auto">
            <a:xfrm>
              <a:off x="2489200" y="5351463"/>
              <a:ext cx="1225550" cy="642938"/>
            </a:xfrm>
            <a:custGeom>
              <a:avLst/>
              <a:gdLst>
                <a:gd name="T0" fmla="*/ 0 w 6432"/>
                <a:gd name="T1" fmla="*/ 563 h 3376"/>
                <a:gd name="T2" fmla="*/ 563 w 6432"/>
                <a:gd name="T3" fmla="*/ 0 h 3376"/>
                <a:gd name="T4" fmla="*/ 5870 w 6432"/>
                <a:gd name="T5" fmla="*/ 0 h 3376"/>
                <a:gd name="T6" fmla="*/ 6432 w 6432"/>
                <a:gd name="T7" fmla="*/ 563 h 3376"/>
                <a:gd name="T8" fmla="*/ 6432 w 6432"/>
                <a:gd name="T9" fmla="*/ 2814 h 3376"/>
                <a:gd name="T10" fmla="*/ 5870 w 6432"/>
                <a:gd name="T11" fmla="*/ 3376 h 3376"/>
                <a:gd name="T12" fmla="*/ 563 w 6432"/>
                <a:gd name="T13" fmla="*/ 3376 h 3376"/>
                <a:gd name="T14" fmla="*/ 0 w 6432"/>
                <a:gd name="T15" fmla="*/ 2814 h 3376"/>
                <a:gd name="T16" fmla="*/ 0 w 6432"/>
                <a:gd name="T17" fmla="*/ 563 h 3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432" h="3376">
                  <a:moveTo>
                    <a:pt x="0" y="563"/>
                  </a:moveTo>
                  <a:cubicBezTo>
                    <a:pt x="0" y="252"/>
                    <a:pt x="252" y="0"/>
                    <a:pt x="563" y="0"/>
                  </a:cubicBezTo>
                  <a:lnTo>
                    <a:pt x="5870" y="0"/>
                  </a:lnTo>
                  <a:cubicBezTo>
                    <a:pt x="6181" y="0"/>
                    <a:pt x="6432" y="252"/>
                    <a:pt x="6432" y="563"/>
                  </a:cubicBezTo>
                  <a:lnTo>
                    <a:pt x="6432" y="2814"/>
                  </a:lnTo>
                  <a:cubicBezTo>
                    <a:pt x="6432" y="3125"/>
                    <a:pt x="6181" y="3376"/>
                    <a:pt x="5870" y="3376"/>
                  </a:cubicBezTo>
                  <a:lnTo>
                    <a:pt x="563" y="3376"/>
                  </a:lnTo>
                  <a:cubicBezTo>
                    <a:pt x="252" y="3376"/>
                    <a:pt x="0" y="3125"/>
                    <a:pt x="0" y="2814"/>
                  </a:cubicBezTo>
                  <a:lnTo>
                    <a:pt x="0" y="563"/>
                  </a:lnTo>
                  <a:close/>
                </a:path>
              </a:pathLst>
            </a:custGeom>
            <a:noFill/>
            <a:ln w="28575" cap="flat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" name="Rectangle 45"/>
            <p:cNvSpPr>
              <a:spLocks noChangeArrowheads="1"/>
            </p:cNvSpPr>
            <p:nvPr/>
          </p:nvSpPr>
          <p:spPr bwMode="auto">
            <a:xfrm>
              <a:off x="2841625" y="5362575"/>
              <a:ext cx="650875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n=72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6"/>
            <p:cNvSpPr>
              <a:spLocks noChangeArrowheads="1"/>
            </p:cNvSpPr>
            <p:nvPr/>
          </p:nvSpPr>
          <p:spPr bwMode="auto">
            <a:xfrm>
              <a:off x="2659063" y="5667375"/>
              <a:ext cx="1017587" cy="379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2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included</a:t>
              </a:r>
              <a:endParaRPr kumimoji="0" lang="fr-FR" alt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Freeform 47"/>
            <p:cNvSpPr>
              <a:spLocks noEditPoints="1"/>
            </p:cNvSpPr>
            <p:nvPr/>
          </p:nvSpPr>
          <p:spPr bwMode="auto">
            <a:xfrm>
              <a:off x="3035300" y="2116138"/>
              <a:ext cx="133350" cy="1004888"/>
            </a:xfrm>
            <a:custGeom>
              <a:avLst/>
              <a:gdLst>
                <a:gd name="T0" fmla="*/ 857 w 1411"/>
                <a:gd name="T1" fmla="*/ 0 h 10554"/>
                <a:gd name="T2" fmla="*/ 857 w 1411"/>
                <a:gd name="T3" fmla="*/ 10252 h 10554"/>
                <a:gd name="T4" fmla="*/ 553 w 1411"/>
                <a:gd name="T5" fmla="*/ 10252 h 10554"/>
                <a:gd name="T6" fmla="*/ 553 w 1411"/>
                <a:gd name="T7" fmla="*/ 0 h 10554"/>
                <a:gd name="T8" fmla="*/ 857 w 1411"/>
                <a:gd name="T9" fmla="*/ 0 h 10554"/>
                <a:gd name="T10" fmla="*/ 1369 w 1411"/>
                <a:gd name="T11" fmla="*/ 9417 h 10554"/>
                <a:gd name="T12" fmla="*/ 705 w 1411"/>
                <a:gd name="T13" fmla="*/ 10554 h 10554"/>
                <a:gd name="T14" fmla="*/ 42 w 1411"/>
                <a:gd name="T15" fmla="*/ 9417 h 10554"/>
                <a:gd name="T16" fmla="*/ 97 w 1411"/>
                <a:gd name="T17" fmla="*/ 9209 h 10554"/>
                <a:gd name="T18" fmla="*/ 305 w 1411"/>
                <a:gd name="T19" fmla="*/ 9263 h 10554"/>
                <a:gd name="T20" fmla="*/ 305 w 1411"/>
                <a:gd name="T21" fmla="*/ 9263 h 10554"/>
                <a:gd name="T22" fmla="*/ 837 w 1411"/>
                <a:gd name="T23" fmla="*/ 10175 h 10554"/>
                <a:gd name="T24" fmla="*/ 574 w 1411"/>
                <a:gd name="T25" fmla="*/ 10175 h 10554"/>
                <a:gd name="T26" fmla="*/ 1106 w 1411"/>
                <a:gd name="T27" fmla="*/ 9263 h 10554"/>
                <a:gd name="T28" fmla="*/ 1314 w 1411"/>
                <a:gd name="T29" fmla="*/ 9209 h 10554"/>
                <a:gd name="T30" fmla="*/ 1369 w 1411"/>
                <a:gd name="T31" fmla="*/ 9417 h 105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411" h="10554">
                  <a:moveTo>
                    <a:pt x="857" y="0"/>
                  </a:moveTo>
                  <a:lnTo>
                    <a:pt x="857" y="10252"/>
                  </a:lnTo>
                  <a:lnTo>
                    <a:pt x="553" y="10252"/>
                  </a:lnTo>
                  <a:lnTo>
                    <a:pt x="553" y="0"/>
                  </a:lnTo>
                  <a:lnTo>
                    <a:pt x="857" y="0"/>
                  </a:lnTo>
                  <a:close/>
                  <a:moveTo>
                    <a:pt x="1369" y="9417"/>
                  </a:moveTo>
                  <a:lnTo>
                    <a:pt x="705" y="10554"/>
                  </a:lnTo>
                  <a:lnTo>
                    <a:pt x="42" y="9417"/>
                  </a:lnTo>
                  <a:cubicBezTo>
                    <a:pt x="0" y="9344"/>
                    <a:pt x="24" y="9251"/>
                    <a:pt x="97" y="9209"/>
                  </a:cubicBezTo>
                  <a:cubicBezTo>
                    <a:pt x="169" y="9166"/>
                    <a:pt x="262" y="9191"/>
                    <a:pt x="305" y="9263"/>
                  </a:cubicBezTo>
                  <a:lnTo>
                    <a:pt x="305" y="9263"/>
                  </a:lnTo>
                  <a:lnTo>
                    <a:pt x="837" y="10175"/>
                  </a:lnTo>
                  <a:lnTo>
                    <a:pt x="574" y="10175"/>
                  </a:lnTo>
                  <a:lnTo>
                    <a:pt x="1106" y="9263"/>
                  </a:lnTo>
                  <a:cubicBezTo>
                    <a:pt x="1148" y="9191"/>
                    <a:pt x="1242" y="9166"/>
                    <a:pt x="1314" y="9209"/>
                  </a:cubicBezTo>
                  <a:cubicBezTo>
                    <a:pt x="1387" y="9251"/>
                    <a:pt x="1411" y="9344"/>
                    <a:pt x="1369" y="9417"/>
                  </a:cubicBezTo>
                  <a:close/>
                </a:path>
              </a:pathLst>
            </a:custGeom>
            <a:solidFill>
              <a:srgbClr val="0070C0"/>
            </a:solidFill>
            <a:ln w="0" cap="flat">
              <a:solidFill>
                <a:srgbClr val="0070C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" name="Freeform 48"/>
            <p:cNvSpPr>
              <a:spLocks noEditPoints="1"/>
            </p:cNvSpPr>
            <p:nvPr/>
          </p:nvSpPr>
          <p:spPr bwMode="auto">
            <a:xfrm>
              <a:off x="3087688" y="2116138"/>
              <a:ext cx="990600" cy="555625"/>
            </a:xfrm>
            <a:custGeom>
              <a:avLst/>
              <a:gdLst>
                <a:gd name="T0" fmla="*/ 0 w 10398"/>
                <a:gd name="T1" fmla="*/ 0 h 5847"/>
                <a:gd name="T2" fmla="*/ 0 w 10398"/>
                <a:gd name="T3" fmla="*/ 5141 h 5847"/>
                <a:gd name="T4" fmla="*/ 152 w 10398"/>
                <a:gd name="T5" fmla="*/ 5293 h 5847"/>
                <a:gd name="T6" fmla="*/ 10096 w 10398"/>
                <a:gd name="T7" fmla="*/ 5293 h 5847"/>
                <a:gd name="T8" fmla="*/ 10096 w 10398"/>
                <a:gd name="T9" fmla="*/ 4989 h 5847"/>
                <a:gd name="T10" fmla="*/ 152 w 10398"/>
                <a:gd name="T11" fmla="*/ 4989 h 5847"/>
                <a:gd name="T12" fmla="*/ 304 w 10398"/>
                <a:gd name="T13" fmla="*/ 5141 h 5847"/>
                <a:gd name="T14" fmla="*/ 304 w 10398"/>
                <a:gd name="T15" fmla="*/ 0 h 5847"/>
                <a:gd name="T16" fmla="*/ 0 w 10398"/>
                <a:gd name="T17" fmla="*/ 0 h 5847"/>
                <a:gd name="T18" fmla="*/ 9261 w 10398"/>
                <a:gd name="T19" fmla="*/ 5805 h 5847"/>
                <a:gd name="T20" fmla="*/ 10398 w 10398"/>
                <a:gd name="T21" fmla="*/ 5141 h 5847"/>
                <a:gd name="T22" fmla="*/ 9261 w 10398"/>
                <a:gd name="T23" fmla="*/ 4478 h 5847"/>
                <a:gd name="T24" fmla="*/ 9053 w 10398"/>
                <a:gd name="T25" fmla="*/ 4533 h 5847"/>
                <a:gd name="T26" fmla="*/ 9108 w 10398"/>
                <a:gd name="T27" fmla="*/ 4741 h 5847"/>
                <a:gd name="T28" fmla="*/ 10020 w 10398"/>
                <a:gd name="T29" fmla="*/ 5273 h 5847"/>
                <a:gd name="T30" fmla="*/ 10020 w 10398"/>
                <a:gd name="T31" fmla="*/ 5010 h 5847"/>
                <a:gd name="T32" fmla="*/ 9108 w 10398"/>
                <a:gd name="T33" fmla="*/ 5542 h 5847"/>
                <a:gd name="T34" fmla="*/ 9053 w 10398"/>
                <a:gd name="T35" fmla="*/ 5750 h 5847"/>
                <a:gd name="T36" fmla="*/ 9261 w 10398"/>
                <a:gd name="T37" fmla="*/ 5805 h 58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10398" h="5847">
                  <a:moveTo>
                    <a:pt x="0" y="0"/>
                  </a:moveTo>
                  <a:lnTo>
                    <a:pt x="0" y="5141"/>
                  </a:lnTo>
                  <a:cubicBezTo>
                    <a:pt x="0" y="5225"/>
                    <a:pt x="69" y="5293"/>
                    <a:pt x="152" y="5293"/>
                  </a:cubicBezTo>
                  <a:lnTo>
                    <a:pt x="10096" y="5293"/>
                  </a:lnTo>
                  <a:lnTo>
                    <a:pt x="10096" y="4989"/>
                  </a:lnTo>
                  <a:lnTo>
                    <a:pt x="152" y="4989"/>
                  </a:lnTo>
                  <a:lnTo>
                    <a:pt x="304" y="5141"/>
                  </a:lnTo>
                  <a:lnTo>
                    <a:pt x="304" y="0"/>
                  </a:lnTo>
                  <a:lnTo>
                    <a:pt x="0" y="0"/>
                  </a:lnTo>
                  <a:close/>
                  <a:moveTo>
                    <a:pt x="9261" y="5805"/>
                  </a:moveTo>
                  <a:lnTo>
                    <a:pt x="10398" y="5141"/>
                  </a:lnTo>
                  <a:lnTo>
                    <a:pt x="9261" y="4478"/>
                  </a:lnTo>
                  <a:cubicBezTo>
                    <a:pt x="9188" y="4436"/>
                    <a:pt x="9095" y="4460"/>
                    <a:pt x="9053" y="4533"/>
                  </a:cubicBezTo>
                  <a:cubicBezTo>
                    <a:pt x="9011" y="4605"/>
                    <a:pt x="9035" y="4698"/>
                    <a:pt x="9108" y="4741"/>
                  </a:cubicBezTo>
                  <a:lnTo>
                    <a:pt x="10020" y="5273"/>
                  </a:lnTo>
                  <a:lnTo>
                    <a:pt x="10020" y="5010"/>
                  </a:lnTo>
                  <a:lnTo>
                    <a:pt x="9108" y="5542"/>
                  </a:lnTo>
                  <a:cubicBezTo>
                    <a:pt x="9035" y="5584"/>
                    <a:pt x="9011" y="5677"/>
                    <a:pt x="9053" y="5750"/>
                  </a:cubicBezTo>
                  <a:cubicBezTo>
                    <a:pt x="9095" y="5822"/>
                    <a:pt x="9188" y="5847"/>
                    <a:pt x="9261" y="5805"/>
                  </a:cubicBezTo>
                  <a:close/>
                </a:path>
              </a:pathLst>
            </a:custGeom>
            <a:solidFill>
              <a:srgbClr val="0070C0"/>
            </a:solidFill>
            <a:ln w="0" cap="flat">
              <a:solidFill>
                <a:srgbClr val="0070C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" name="Freeform 49"/>
            <p:cNvSpPr>
              <a:spLocks noEditPoints="1"/>
            </p:cNvSpPr>
            <p:nvPr/>
          </p:nvSpPr>
          <p:spPr bwMode="auto">
            <a:xfrm>
              <a:off x="3087688" y="3833813"/>
              <a:ext cx="990600" cy="508000"/>
            </a:xfrm>
            <a:custGeom>
              <a:avLst/>
              <a:gdLst>
                <a:gd name="T0" fmla="*/ 0 w 5199"/>
                <a:gd name="T1" fmla="*/ 0 h 2661"/>
                <a:gd name="T2" fmla="*/ 0 w 5199"/>
                <a:gd name="T3" fmla="*/ 2308 h 2661"/>
                <a:gd name="T4" fmla="*/ 76 w 5199"/>
                <a:gd name="T5" fmla="*/ 2384 h 2661"/>
                <a:gd name="T6" fmla="*/ 5048 w 5199"/>
                <a:gd name="T7" fmla="*/ 2384 h 2661"/>
                <a:gd name="T8" fmla="*/ 5048 w 5199"/>
                <a:gd name="T9" fmla="*/ 2232 h 2661"/>
                <a:gd name="T10" fmla="*/ 76 w 5199"/>
                <a:gd name="T11" fmla="*/ 2232 h 2661"/>
                <a:gd name="T12" fmla="*/ 152 w 5199"/>
                <a:gd name="T13" fmla="*/ 2308 h 2661"/>
                <a:gd name="T14" fmla="*/ 152 w 5199"/>
                <a:gd name="T15" fmla="*/ 0 h 2661"/>
                <a:gd name="T16" fmla="*/ 0 w 5199"/>
                <a:gd name="T17" fmla="*/ 0 h 2661"/>
                <a:gd name="T18" fmla="*/ 4631 w 5199"/>
                <a:gd name="T19" fmla="*/ 2640 h 2661"/>
                <a:gd name="T20" fmla="*/ 5199 w 5199"/>
                <a:gd name="T21" fmla="*/ 2308 h 2661"/>
                <a:gd name="T22" fmla="*/ 4631 w 5199"/>
                <a:gd name="T23" fmla="*/ 1976 h 2661"/>
                <a:gd name="T24" fmla="*/ 4527 w 5199"/>
                <a:gd name="T25" fmla="*/ 2004 h 2661"/>
                <a:gd name="T26" fmla="*/ 4554 w 5199"/>
                <a:gd name="T27" fmla="*/ 2108 h 2661"/>
                <a:gd name="T28" fmla="*/ 5010 w 5199"/>
                <a:gd name="T29" fmla="*/ 2374 h 2661"/>
                <a:gd name="T30" fmla="*/ 5010 w 5199"/>
                <a:gd name="T31" fmla="*/ 2242 h 2661"/>
                <a:gd name="T32" fmla="*/ 4554 w 5199"/>
                <a:gd name="T33" fmla="*/ 2508 h 2661"/>
                <a:gd name="T34" fmla="*/ 4527 w 5199"/>
                <a:gd name="T35" fmla="*/ 2612 h 2661"/>
                <a:gd name="T36" fmla="*/ 4631 w 5199"/>
                <a:gd name="T37" fmla="*/ 2640 h 2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5199" h="2661">
                  <a:moveTo>
                    <a:pt x="0" y="0"/>
                  </a:moveTo>
                  <a:lnTo>
                    <a:pt x="0" y="2308"/>
                  </a:lnTo>
                  <a:cubicBezTo>
                    <a:pt x="0" y="2350"/>
                    <a:pt x="34" y="2384"/>
                    <a:pt x="76" y="2384"/>
                  </a:cubicBezTo>
                  <a:lnTo>
                    <a:pt x="5048" y="2384"/>
                  </a:lnTo>
                  <a:lnTo>
                    <a:pt x="5048" y="2232"/>
                  </a:lnTo>
                  <a:lnTo>
                    <a:pt x="76" y="2232"/>
                  </a:lnTo>
                  <a:lnTo>
                    <a:pt x="152" y="2308"/>
                  </a:lnTo>
                  <a:lnTo>
                    <a:pt x="152" y="0"/>
                  </a:lnTo>
                  <a:lnTo>
                    <a:pt x="0" y="0"/>
                  </a:lnTo>
                  <a:close/>
                  <a:moveTo>
                    <a:pt x="4631" y="2640"/>
                  </a:moveTo>
                  <a:lnTo>
                    <a:pt x="5199" y="2308"/>
                  </a:lnTo>
                  <a:lnTo>
                    <a:pt x="4631" y="1976"/>
                  </a:lnTo>
                  <a:cubicBezTo>
                    <a:pt x="4594" y="1955"/>
                    <a:pt x="4548" y="1967"/>
                    <a:pt x="4527" y="2004"/>
                  </a:cubicBezTo>
                  <a:cubicBezTo>
                    <a:pt x="4506" y="2040"/>
                    <a:pt x="4518" y="2086"/>
                    <a:pt x="4554" y="2108"/>
                  </a:cubicBezTo>
                  <a:lnTo>
                    <a:pt x="5010" y="2374"/>
                  </a:lnTo>
                  <a:lnTo>
                    <a:pt x="5010" y="2242"/>
                  </a:lnTo>
                  <a:lnTo>
                    <a:pt x="4554" y="2508"/>
                  </a:lnTo>
                  <a:cubicBezTo>
                    <a:pt x="4518" y="2529"/>
                    <a:pt x="4506" y="2576"/>
                    <a:pt x="4527" y="2612"/>
                  </a:cubicBezTo>
                  <a:cubicBezTo>
                    <a:pt x="4548" y="2648"/>
                    <a:pt x="4594" y="2661"/>
                    <a:pt x="4631" y="2640"/>
                  </a:cubicBezTo>
                  <a:close/>
                </a:path>
              </a:pathLst>
            </a:custGeom>
            <a:solidFill>
              <a:srgbClr val="0070C0"/>
            </a:solidFill>
            <a:ln w="0" cap="flat">
              <a:solidFill>
                <a:srgbClr val="0070C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" name="Freeform 50"/>
            <p:cNvSpPr>
              <a:spLocks noEditPoints="1"/>
            </p:cNvSpPr>
            <p:nvPr/>
          </p:nvSpPr>
          <p:spPr bwMode="auto">
            <a:xfrm>
              <a:off x="3035300" y="3833813"/>
              <a:ext cx="133350" cy="1517650"/>
            </a:xfrm>
            <a:custGeom>
              <a:avLst/>
              <a:gdLst>
                <a:gd name="T0" fmla="*/ 276 w 705"/>
                <a:gd name="T1" fmla="*/ 0 h 7965"/>
                <a:gd name="T2" fmla="*/ 276 w 705"/>
                <a:gd name="T3" fmla="*/ 7814 h 7965"/>
                <a:gd name="T4" fmla="*/ 428 w 705"/>
                <a:gd name="T5" fmla="*/ 7814 h 7965"/>
                <a:gd name="T6" fmla="*/ 428 w 705"/>
                <a:gd name="T7" fmla="*/ 0 h 7965"/>
                <a:gd name="T8" fmla="*/ 276 w 705"/>
                <a:gd name="T9" fmla="*/ 0 h 7965"/>
                <a:gd name="T10" fmla="*/ 21 w 705"/>
                <a:gd name="T11" fmla="*/ 7396 h 7965"/>
                <a:gd name="T12" fmla="*/ 352 w 705"/>
                <a:gd name="T13" fmla="*/ 7965 h 7965"/>
                <a:gd name="T14" fmla="*/ 684 w 705"/>
                <a:gd name="T15" fmla="*/ 7396 h 7965"/>
                <a:gd name="T16" fmla="*/ 657 w 705"/>
                <a:gd name="T17" fmla="*/ 7292 h 7965"/>
                <a:gd name="T18" fmla="*/ 553 w 705"/>
                <a:gd name="T19" fmla="*/ 7319 h 7965"/>
                <a:gd name="T20" fmla="*/ 553 w 705"/>
                <a:gd name="T21" fmla="*/ 7319 h 7965"/>
                <a:gd name="T22" fmla="*/ 287 w 705"/>
                <a:gd name="T23" fmla="*/ 7775 h 7965"/>
                <a:gd name="T24" fmla="*/ 418 w 705"/>
                <a:gd name="T25" fmla="*/ 7775 h 7965"/>
                <a:gd name="T26" fmla="*/ 152 w 705"/>
                <a:gd name="T27" fmla="*/ 7319 h 7965"/>
                <a:gd name="T28" fmla="*/ 48 w 705"/>
                <a:gd name="T29" fmla="*/ 7292 h 7965"/>
                <a:gd name="T30" fmla="*/ 21 w 705"/>
                <a:gd name="T31" fmla="*/ 7396 h 79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705" h="7965">
                  <a:moveTo>
                    <a:pt x="276" y="0"/>
                  </a:moveTo>
                  <a:lnTo>
                    <a:pt x="276" y="7814"/>
                  </a:lnTo>
                  <a:lnTo>
                    <a:pt x="428" y="7814"/>
                  </a:lnTo>
                  <a:lnTo>
                    <a:pt x="428" y="0"/>
                  </a:lnTo>
                  <a:lnTo>
                    <a:pt x="276" y="0"/>
                  </a:lnTo>
                  <a:close/>
                  <a:moveTo>
                    <a:pt x="21" y="7396"/>
                  </a:moveTo>
                  <a:lnTo>
                    <a:pt x="352" y="7965"/>
                  </a:lnTo>
                  <a:lnTo>
                    <a:pt x="684" y="7396"/>
                  </a:lnTo>
                  <a:cubicBezTo>
                    <a:pt x="705" y="7360"/>
                    <a:pt x="693" y="7313"/>
                    <a:pt x="657" y="7292"/>
                  </a:cubicBezTo>
                  <a:cubicBezTo>
                    <a:pt x="621" y="7271"/>
                    <a:pt x="574" y="7283"/>
                    <a:pt x="553" y="7319"/>
                  </a:cubicBezTo>
                  <a:lnTo>
                    <a:pt x="553" y="7319"/>
                  </a:lnTo>
                  <a:lnTo>
                    <a:pt x="287" y="7775"/>
                  </a:lnTo>
                  <a:lnTo>
                    <a:pt x="418" y="7775"/>
                  </a:lnTo>
                  <a:lnTo>
                    <a:pt x="152" y="7319"/>
                  </a:lnTo>
                  <a:cubicBezTo>
                    <a:pt x="131" y="7283"/>
                    <a:pt x="84" y="7271"/>
                    <a:pt x="48" y="7292"/>
                  </a:cubicBezTo>
                  <a:cubicBezTo>
                    <a:pt x="12" y="7313"/>
                    <a:pt x="0" y="7360"/>
                    <a:pt x="21" y="7396"/>
                  </a:cubicBezTo>
                  <a:close/>
                </a:path>
              </a:pathLst>
            </a:custGeom>
            <a:solidFill>
              <a:srgbClr val="0070C0"/>
            </a:solidFill>
            <a:ln w="0" cap="flat">
              <a:solidFill>
                <a:srgbClr val="0070C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50" name="Rectangle 49"/>
          <p:cNvSpPr/>
          <p:nvPr/>
        </p:nvSpPr>
        <p:spPr>
          <a:xfrm>
            <a:off x="107504" y="5445224"/>
            <a:ext cx="4572000" cy="40011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GB" sz="1000" dirty="0" smtClean="0"/>
              <a:t>Additional figure 1</a:t>
            </a:r>
            <a:endParaRPr lang="en-GB" sz="1000" dirty="0" smtClean="0"/>
          </a:p>
          <a:p>
            <a:pPr algn="just"/>
            <a:r>
              <a:rPr lang="en-GB" sz="1000" dirty="0" smtClean="0"/>
              <a:t>Flow </a:t>
            </a:r>
            <a:r>
              <a:rPr lang="en-GB" sz="1000" dirty="0"/>
              <a:t>c</a:t>
            </a:r>
            <a:r>
              <a:rPr lang="en-GB" sz="1000" dirty="0" smtClean="0"/>
              <a:t>hart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3868211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0</Words>
  <Application>Microsoft Office PowerPoint</Application>
  <PresentationFormat>Affichage à l'écra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2</cp:revision>
  <dcterms:created xsi:type="dcterms:W3CDTF">2018-05-31T17:06:28Z</dcterms:created>
  <dcterms:modified xsi:type="dcterms:W3CDTF">2018-11-06T19:56:33Z</dcterms:modified>
</cp:coreProperties>
</file>